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D9E0E1-1499-42D2-B9FB-28F848DCFA9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C03FC6-4FBB-4A95-9E56-0784D1E601A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F5451-5F83-4026-AA80-59ADAFD62E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675F9-25D1-4AE2-8C89-DCF1EE9736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A5BAF0-53F9-422F-BD08-804E6DB344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E21A1-6F08-4F42-A3EB-83FA9130E4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23D0F-0C92-4C1C-8BC5-191D86C281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80AE8-3262-45A6-81FC-13C0618271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C28F4-84A1-4725-A7DC-5E4A6FA66F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184A2-C49F-4D52-93D8-8C61724D5B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5755A-9850-4A19-BF96-E8F7E6DD7F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A1BCA-EF17-402E-BF91-8E4C8BB7A1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7B91F-1C2A-4FA2-ADB3-A96C0154F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5C1BC-750D-47A1-8514-39CA31ADAF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8D7A6B-DBEE-47F1-83FE-F7B2580CCE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392040" y="5943600"/>
            <a:ext cx="822960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. 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-4: No detection of mosaicism in a “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pool” analysis of the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GFR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15/18 bp deletions in 6,400 individua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6" descr="11-13-1"/>
          <p:cNvPicPr/>
          <p:nvPr/>
        </p:nvPicPr>
        <p:blipFill>
          <a:blip r:embed="rId1"/>
          <a:srcRect l="14750" t="0" r="26171" b="1417"/>
          <a:stretch/>
        </p:blipFill>
        <p:spPr>
          <a:xfrm>
            <a:off x="838080" y="762120"/>
            <a:ext cx="7391520" cy="464796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8"/>
          <p:cNvSpPr/>
          <p:nvPr/>
        </p:nvSpPr>
        <p:spPr>
          <a:xfrm>
            <a:off x="1537200" y="262080"/>
            <a:ext cx="217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nalytical 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9"/>
          <p:cNvSpPr/>
          <p:nvPr/>
        </p:nvSpPr>
        <p:spPr>
          <a:xfrm>
            <a:off x="4321080" y="262080"/>
            <a:ext cx="19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Negative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10"/>
          <p:cNvSpPr/>
          <p:nvPr/>
        </p:nvSpPr>
        <p:spPr>
          <a:xfrm rot="5407800">
            <a:off x="2487240" y="-465120"/>
            <a:ext cx="236520" cy="2274840"/>
          </a:xfrm>
          <a:custGeom>
            <a:avLst/>
            <a:gdLst>
              <a:gd name="textAreaLeft" fmla="*/ 151200 w 236520"/>
              <a:gd name="textAreaRight" fmla="*/ 236880 w 236520"/>
              <a:gd name="textAreaTop" fmla="*/ 67680 h 2274840"/>
              <a:gd name="textAreaBottom" fmla="*/ 2207160 h 2274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AutoShape 11"/>
          <p:cNvSpPr/>
          <p:nvPr/>
        </p:nvSpPr>
        <p:spPr>
          <a:xfrm rot="5407800">
            <a:off x="5145120" y="-423000"/>
            <a:ext cx="236880" cy="2210040"/>
          </a:xfrm>
          <a:custGeom>
            <a:avLst/>
            <a:gdLst>
              <a:gd name="textAreaLeft" fmla="*/ 151560 w 236880"/>
              <a:gd name="textAreaRight" fmla="*/ 237240 w 236880"/>
              <a:gd name="textAreaTop" fmla="*/ 65880 h 2210040"/>
              <a:gd name="textAreaBottom" fmla="*/ 2144160 h 2210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"/>
          <p:cNvSpPr/>
          <p:nvPr/>
        </p:nvSpPr>
        <p:spPr>
          <a:xfrm>
            <a:off x="696960" y="719280"/>
            <a:ext cx="701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0    10     4       2       1    ½     ¼      0      0       0      0      0       0     0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4"/>
          <p:cNvSpPr/>
          <p:nvPr/>
        </p:nvSpPr>
        <p:spPr>
          <a:xfrm>
            <a:off x="1735560" y="2787480"/>
            <a:ext cx="1869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00"/>
                </a:solidFill>
                <a:latin typeface="Tahoma"/>
              </a:rPr>
              <a:t>Analytical Sensitiv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5"/>
          <p:cNvSpPr/>
          <p:nvPr/>
        </p:nvSpPr>
        <p:spPr>
          <a:xfrm>
            <a:off x="4476600" y="277668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00"/>
                </a:solidFill>
                <a:latin typeface="Tahoma"/>
              </a:rPr>
              <a:t>Negative 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16"/>
          <p:cNvSpPr/>
          <p:nvPr/>
        </p:nvSpPr>
        <p:spPr>
          <a:xfrm rot="5407800">
            <a:off x="2520720" y="2015640"/>
            <a:ext cx="236520" cy="2274840"/>
          </a:xfrm>
          <a:custGeom>
            <a:avLst/>
            <a:gdLst>
              <a:gd name="textAreaLeft" fmla="*/ 151200 w 236520"/>
              <a:gd name="textAreaRight" fmla="*/ 236880 w 236520"/>
              <a:gd name="textAreaTop" fmla="*/ 67680 h 2274840"/>
              <a:gd name="textAreaBottom" fmla="*/ 2207160 h 2274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17"/>
          <p:cNvSpPr/>
          <p:nvPr/>
        </p:nvSpPr>
        <p:spPr>
          <a:xfrm rot="5407800">
            <a:off x="5178960" y="2058120"/>
            <a:ext cx="236520" cy="2209680"/>
          </a:xfrm>
          <a:custGeom>
            <a:avLst/>
            <a:gdLst>
              <a:gd name="textAreaLeft" fmla="*/ 151200 w 236520"/>
              <a:gd name="textAreaRight" fmla="*/ 236880 w 236520"/>
              <a:gd name="textAreaTop" fmla="*/ 65880 h 2209680"/>
              <a:gd name="textAreaBottom" fmla="*/ 2143800 h 2209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032"/>
                  <a:pt x="10800" y="2063"/>
                </a:cubicBezTo>
                <a:lnTo>
                  <a:pt x="10800" y="8737"/>
                </a:lnTo>
                <a:cubicBezTo>
                  <a:pt x="10800" y="9769"/>
                  <a:pt x="5400" y="10800"/>
                  <a:pt x="0" y="10800"/>
                </a:cubicBezTo>
                <a:cubicBezTo>
                  <a:pt x="5400" y="10800"/>
                  <a:pt x="10800" y="11832"/>
                  <a:pt x="10800" y="12863"/>
                </a:cubicBezTo>
                <a:lnTo>
                  <a:pt x="10800" y="19537"/>
                </a:lnTo>
                <a:cubicBezTo>
                  <a:pt x="10800" y="20569"/>
                  <a:pt x="16200" y="21600"/>
                  <a:pt x="21600" y="21600"/>
                </a:cubicBezTo>
              </a:path>
            </a:pathLst>
          </a:custGeom>
          <a:noFill/>
          <a:ln w="316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 anchorCtr="1" vert="eaVert" rot="10800000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8"/>
          <p:cNvSpPr/>
          <p:nvPr/>
        </p:nvSpPr>
        <p:spPr>
          <a:xfrm>
            <a:off x="730080" y="3200400"/>
            <a:ext cx="701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100    10     4       2       1    ½     ¼      0      0       0      0      0       0     0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9"/>
          <p:cNvSpPr/>
          <p:nvPr/>
        </p:nvSpPr>
        <p:spPr>
          <a:xfrm>
            <a:off x="674640" y="1925640"/>
            <a:ext cx="771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00"/>
                </a:solidFill>
                <a:latin typeface="Arial"/>
              </a:rPr>
              <a:t>         </a:t>
            </a:r>
            <a:r>
              <a:rPr b="0" lang="en-US" sz="1000" spc="-1" strike="noStrike">
                <a:solidFill>
                  <a:srgbClr val="ffff00"/>
                </a:solidFill>
                <a:latin typeface="Arial"/>
              </a:rPr>
              <a:t>M        4+      2+         A      B         C        D         E        F        G         H         I        J         K         L        M        N         O        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0"/>
          <p:cNvSpPr/>
          <p:nvPr/>
        </p:nvSpPr>
        <p:spPr>
          <a:xfrm>
            <a:off x="696960" y="4314960"/>
            <a:ext cx="7718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66"/>
                </a:solidFill>
                <a:latin typeface="Tahoma"/>
              </a:rPr>
              <a:t>       </a:t>
            </a:r>
            <a:r>
              <a:rPr b="0" lang="en-US" sz="1200" spc="-1" strike="noStrike">
                <a:solidFill>
                  <a:srgbClr val="ffff00"/>
                </a:solidFill>
                <a:latin typeface="Tahoma"/>
              </a:rPr>
              <a:t>M    4+    2+     A      B      C      D      E      F      G      H      I       J       K      L     M      N      O     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1"/>
          <p:cNvSpPr/>
          <p:nvPr/>
        </p:nvSpPr>
        <p:spPr>
          <a:xfrm>
            <a:off x="925560" y="160020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00"/>
                </a:solidFill>
                <a:latin typeface="Tahoma"/>
              </a:rPr>
              <a:t>15bp dele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2"/>
          <p:cNvSpPr/>
          <p:nvPr/>
        </p:nvSpPr>
        <p:spPr>
          <a:xfrm>
            <a:off x="914400" y="396252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00"/>
                </a:solidFill>
                <a:latin typeface="Tahoma"/>
              </a:rPr>
              <a:t>18bp dele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3"/>
          <p:cNvSpPr/>
          <p:nvPr/>
        </p:nvSpPr>
        <p:spPr>
          <a:xfrm>
            <a:off x="990720" y="91440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00"/>
                </a:solidFill>
                <a:latin typeface="Arial"/>
              </a:rPr>
              <a:t>Copy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4"/>
          <p:cNvSpPr/>
          <p:nvPr/>
        </p:nvSpPr>
        <p:spPr>
          <a:xfrm>
            <a:off x="1001880" y="33638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00"/>
                </a:solidFill>
                <a:latin typeface="Arial"/>
              </a:rPr>
              <a:t>Copy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7T18:19:55Z</dcterms:created>
  <dc:creator>zhchen</dc:creator>
  <dc:description/>
  <dc:language>en-US</dc:language>
  <cp:lastModifiedBy>zhchen</cp:lastModifiedBy>
  <dcterms:modified xsi:type="dcterms:W3CDTF">2009-07-31T21:48:55Z</dcterms:modified>
  <cp:revision>34</cp:revision>
  <dc:subject/>
  <dc:title>Slide 1</dc:title>
</cp:coreProperties>
</file>